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6C3E2-AC83-A12A-9B8F-D1B007E18C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AF5816-ED8B-2CF3-66A5-64D17115AF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7DDC49-0C5D-0F52-19B0-95BAA7878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8A9D0-26DE-D294-BF7D-14555A998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09132A-C483-331F-72FE-9565CDBF6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4113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CCDC7-A110-C705-640A-5C96D50D8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425F5F-82EE-354F-D192-11159508B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477242-091C-C635-9642-6927EB377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04E04-C2F0-8452-7661-7FB089822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30E1E-36FE-0E2D-0534-CBE775FCE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8454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630C865-75A9-1697-485A-837384F495B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711287-3CE7-8022-1F23-289B7B8064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0E0B81-F42C-EE23-CB91-A6C53D7EC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3F476-42D9-A4A2-C58A-123023061C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55846D-2961-7561-965E-7BFD8D275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1722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B7592B-924F-0289-3652-478D16760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E48435-3FE9-F01F-D255-B867BE510A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B22A-1E42-51F9-24EA-8A88CD5F2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5AB3F8-6295-B2A5-86F3-116FCD4DF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82691C-C9F0-0FE3-8776-D1F8AFB2B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4174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E9AD0-4D5C-EC7A-67F5-09055D391A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9948CF-6B37-13C3-58AF-CC378384AF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335B21-5127-520C-1595-4120E7CB1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F092D-5DED-3FDD-9C9F-6D4A5DFE8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9C79AA-091E-61C0-0496-AC78BDDC6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05950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EAABB-2369-0E54-872E-C14D37750F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E9545-88CA-BC16-F166-FC243204F8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CF1A65-327C-F01D-35F3-F06E1D38BE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92C43C-DBB9-32D3-5951-F2BA2E440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5D4A6B-0D33-3ED6-7D01-5F5C14A0D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112C1-2517-8655-3572-143B31B2C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49596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4FCF3-2387-E9F7-F21C-5FDA2DE96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FACF0A-D11E-076A-C305-1DD1C852A1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EE9FD8E-9231-3507-4E10-D732E42193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2B6412-FFA1-5A6D-DB62-3C9179C25A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7A872CC-9F76-7798-3E3F-18D8902285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C77499-2BB2-EC8B-0594-0B68A3C6F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3958BD-049A-CB19-E558-89E339F62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D89D69-99A3-6623-6AF9-49E6DF3C4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08371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A0ACBD-FC26-278E-84F2-6DEE5628A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77A54B-A756-58B0-ADCE-1174264BE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E25AAB-D098-C659-042F-785ED24F8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A391F5-8D72-ADDB-5140-846E59184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67214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E8E58C-D3F2-264D-1D86-BFF03AE16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0F141A-549F-1E74-D41D-2E7342ED5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E5DF51-B129-8501-5B31-CC06F4909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71455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DFD16-050C-0C1C-7CBD-316AAB6F33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530F4A-BEC5-7354-9245-EEBA008E98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B5F69D-D691-D26F-0456-97FB8AA7D1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BA023B-DBAB-63DB-06D1-CA47EC9B3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652F2C-F89B-538A-7ED5-B5707C88F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C6EC9D-2D95-7442-C38F-280858779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0452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B7600-AEF0-46E4-E611-32C0907DC1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1F79C23-45A1-7C46-7B39-71338F88C2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DE3FDA-C11D-1BDF-7738-3A26A5DA5E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F405B2-C53B-967A-09AA-01B0AB5DE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593441-547C-7D3A-A1D9-DC31C50F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F0EE60-EA2C-5F2C-AE9D-557251B3D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00255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3E0C22-40BD-9F2B-FDCE-B49138106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E336A2-52BA-445F-4AE1-E1EA3C74D1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FDFA3D-56DA-5B00-7820-AC70459876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35C12-83A1-4783-B06B-9F12CB81BDE4}" type="datetimeFigureOut">
              <a:rPr lang="en-DE" smtClean="0"/>
              <a:t>26/05/2022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33F3C3-3B8A-96A8-30F5-D6899D1C4D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79357B-7EC7-4A8C-80A9-7E545FE832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64B8A-9653-4306-BA7A-960C160165B0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89445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A3AE52AE-B2DA-7B91-1ECD-6284513162A0}"/>
              </a:ext>
            </a:extLst>
          </p:cNvPr>
          <p:cNvSpPr txBox="1"/>
          <p:nvPr/>
        </p:nvSpPr>
        <p:spPr>
          <a:xfrm>
            <a:off x="76201" y="46115"/>
            <a:ext cx="12065000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. 3</a:t>
            </a:r>
            <a:endParaRPr lang="en-DE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ontology (GO) enrichment analysis  of genes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wheat and rye 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statistically significant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p-regulated changes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the presence of 2B chromosomes; b) down-regulated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s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the presence of 2B chromosomes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ata from wheat study is on the left side and data from rye study is on the right side.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VIGO was used to summarize and visualize the enriched GO terms related to biological process. 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milar GO terms were grouped based on semantic similarity. Each circle indicates a specific GO term. The circle </a:t>
            </a:r>
            <a:r>
              <a:rPr lang="en-GB" sz="1400" dirty="0" err="1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‘Value’) reflects the number of genes related to the GO term and the size of the circle (‘</a:t>
            </a:r>
            <a:r>
              <a:rPr lang="en-GB" sz="1400" dirty="0" err="1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Size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) is the Log10(Number of annotations for GO Term ID in the </a:t>
            </a:r>
            <a:r>
              <a:rPr lang="en-GB" sz="1400" i="1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yza sativa Japonica 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up  of the EBI GOA database. </a:t>
            </a:r>
            <a:endParaRPr lang="en-DE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8301CC5-9C56-9ED1-D49B-C838DD9659CC}"/>
              </a:ext>
            </a:extLst>
          </p:cNvPr>
          <p:cNvSpPr txBox="1"/>
          <p:nvPr/>
        </p:nvSpPr>
        <p:spPr>
          <a:xfrm>
            <a:off x="76198" y="163285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DE" dirty="0"/>
          </a:p>
        </p:txBody>
      </p:sp>
      <p:pic>
        <p:nvPicPr>
          <p:cNvPr id="13" name="Picture 12" descr="Chart&#10;&#10;Description automatically generated">
            <a:extLst>
              <a:ext uri="{FF2B5EF4-FFF2-40B4-BE49-F238E27FC236}">
                <a16:creationId xmlns:a16="http://schemas.microsoft.com/office/drawing/2014/main" id="{1080FDFD-7214-A631-97D1-AEA5725FF7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1" y="2002190"/>
            <a:ext cx="6134807" cy="4638096"/>
          </a:xfrm>
          <a:prstGeom prst="rect">
            <a:avLst/>
          </a:prstGeom>
        </p:spPr>
      </p:pic>
      <p:pic>
        <p:nvPicPr>
          <p:cNvPr id="15" name="Picture 14" descr="Chart&#10;&#10;Description automatically generated">
            <a:extLst>
              <a:ext uri="{FF2B5EF4-FFF2-40B4-BE49-F238E27FC236}">
                <a16:creationId xmlns:a16="http://schemas.microsoft.com/office/drawing/2014/main" id="{42F21943-1BC6-3BC4-7ACC-30C9AD02B3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4038" y="2002190"/>
            <a:ext cx="6067841" cy="4638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7186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A3AE52AE-B2DA-7B91-1ECD-6284513162A0}"/>
              </a:ext>
            </a:extLst>
          </p:cNvPr>
          <p:cNvSpPr txBox="1"/>
          <p:nvPr/>
        </p:nvSpPr>
        <p:spPr>
          <a:xfrm>
            <a:off x="76201" y="46115"/>
            <a:ext cx="12065000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. 3</a:t>
            </a:r>
            <a:endParaRPr lang="en-DE" sz="1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ontology (GO) enrichment analysis  of genes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wheat and rye 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statistically significant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p-regulated changes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the presence of 2B chromosomes; b) down-regulated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s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the presence of 2B chromosomes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4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ata from wheat study is on the left side and data from rye study is on the right side. </a:t>
            </a:r>
            <a:r>
              <a:rPr lang="en-DE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VIGO was used to summarize and visualize the enriched GO terms related to biological process. 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milar GO terms were grouped based on semantic similarity. Each circle indicates a specific GO term. The circle </a:t>
            </a:r>
            <a:r>
              <a:rPr lang="en-GB" sz="1400" dirty="0" err="1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‘Value’) reflects the number of genes related to the GO term and the size of the circle (‘</a:t>
            </a:r>
            <a:r>
              <a:rPr lang="en-GB" sz="1400" dirty="0" err="1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gSize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’) is the Log10(Number of annotations for GO Term ID in the </a:t>
            </a:r>
            <a:r>
              <a:rPr lang="en-GB" sz="1400" i="1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yza sativa Japonica </a:t>
            </a:r>
            <a:r>
              <a:rPr lang="en-GB" sz="1400" dirty="0">
                <a:solidFill>
                  <a:srgbClr val="3232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up  of the EBI GOA database. </a:t>
            </a:r>
            <a:endParaRPr lang="en-DE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8301CC5-9C56-9ED1-D49B-C838DD9659CC}"/>
              </a:ext>
            </a:extLst>
          </p:cNvPr>
          <p:cNvSpPr txBox="1"/>
          <p:nvPr/>
        </p:nvSpPr>
        <p:spPr>
          <a:xfrm>
            <a:off x="43540" y="163285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DE" dirty="0"/>
          </a:p>
        </p:txBody>
      </p:sp>
      <p:pic>
        <p:nvPicPr>
          <p:cNvPr id="5" name="Picture 4" descr="Chart, bubble chart&#10;&#10;Description automatically generated">
            <a:extLst>
              <a:ext uri="{FF2B5EF4-FFF2-40B4-BE49-F238E27FC236}">
                <a16:creationId xmlns:a16="http://schemas.microsoft.com/office/drawing/2014/main" id="{45E22971-8055-79EA-64C8-4BC0D24D21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0796" y="1957178"/>
            <a:ext cx="6161204" cy="4639565"/>
          </a:xfrm>
          <a:prstGeom prst="rect">
            <a:avLst/>
          </a:prstGeom>
        </p:spPr>
      </p:pic>
      <p:pic>
        <p:nvPicPr>
          <p:cNvPr id="7" name="Picture 6" descr="Chart, bubble chart&#10;&#10;Description automatically generated">
            <a:extLst>
              <a:ext uri="{FF2B5EF4-FFF2-40B4-BE49-F238E27FC236}">
                <a16:creationId xmlns:a16="http://schemas.microsoft.com/office/drawing/2014/main" id="{9D9D7215-0D83-95E4-BD5E-FCA717A948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8" y="1957178"/>
            <a:ext cx="6096239" cy="4639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2686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0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stassia Boudichevskaia</dc:creator>
  <cp:lastModifiedBy>Anastassia Boudichevskaia</cp:lastModifiedBy>
  <cp:revision>6</cp:revision>
  <dcterms:created xsi:type="dcterms:W3CDTF">2022-05-09T07:52:19Z</dcterms:created>
  <dcterms:modified xsi:type="dcterms:W3CDTF">2022-05-26T12:40:06Z</dcterms:modified>
</cp:coreProperties>
</file>